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799263" cy="9929813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8" userDrawn="1">
          <p15:clr>
            <a:srgbClr val="A4A3A4"/>
          </p15:clr>
        </p15:guide>
        <p15:guide id="2" pos="2142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CC66FF"/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>
      <p:cViewPr varScale="1">
        <p:scale>
          <a:sx n="111" d="100"/>
          <a:sy n="111" d="100"/>
        </p:scale>
        <p:origin x="1512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3128"/>
        <p:guide pos="214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052191080180805E-2"/>
          <c:y val="3.5325420951787735E-2"/>
          <c:w val="0.82847718212377386"/>
          <c:h val="0.88222467462418441"/>
        </c:manualLayout>
      </c:layout>
      <c:scatterChart>
        <c:scatterStyle val="lineMarker"/>
        <c:varyColors val="0"/>
        <c:ser>
          <c:idx val="0"/>
          <c:order val="0"/>
          <c:tx>
            <c:v>C2-FQ (1TCM)</c:v>
          </c:tx>
          <c:spPr>
            <a:ln w="28575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2400" b="1" i="0" u="none" strike="noStrike" kern="1200" baseline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B616BD68-2F9F-4583-AB8F-540220ED0130}" type="CELLRANGE">
                      <a:rPr lang="en-US"/>
                      <a:pPr>
                        <a:defRPr sz="2400" b="1">
                          <a:solidFill>
                            <a:srgbClr val="C00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2400" b="1" i="0" u="none" strike="noStrike" kern="1200" baseline="0">
                      <a:solidFill>
                        <a:srgbClr val="C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096F-4870-9EBA-4E93E0391108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94819D47-3E28-467A-A9A3-31A7D194C26E}" type="CELLRANGE">
                      <a:rPr lang="en-FI"/>
                      <a:pPr>
                        <a:defRPr sz="1600">
                          <a:solidFill>
                            <a:srgbClr val="C00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C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1-096F-4870-9EBA-4E93E0391108}"/>
                </c:ext>
              </c:extLst>
            </c:dLbl>
            <c:dLbl>
              <c:idx val="2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33BFFE27-576A-4496-9693-4232E2C0E64F}" type="CELLRANGE">
                      <a:rPr lang="en-FI"/>
                      <a:pPr>
                        <a:defRPr sz="1600">
                          <a:solidFill>
                            <a:srgbClr val="C00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C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096F-4870-9EBA-4E93E0391108}"/>
                </c:ext>
              </c:extLst>
            </c:dLbl>
            <c:dLbl>
              <c:idx val="3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C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663D0813-7018-4D80-81D8-C1A03CDE6822}" type="CELLRANGE">
                      <a:rPr lang="en-FI"/>
                      <a:pPr>
                        <a:defRPr sz="1600">
                          <a:solidFill>
                            <a:srgbClr val="C00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C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3-096F-4870-9EBA-4E93E039110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096F-4870-9EBA-4E93E039110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096F-4870-9EBA-4E93E039110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096F-4870-9EBA-4E93E039110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096F-4870-9EBA-4E93E039110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096F-4870-9EBA-4E93E039110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9-096F-4870-9EBA-4E93E039110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A-096F-4870-9EBA-4E93E039110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B-096F-4870-9EBA-4E93E0391108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C-096F-4870-9EBA-4E93E0391108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D-096F-4870-9EBA-4E93E0391108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E-096F-4870-9EBA-4E93E0391108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F-096F-4870-9EBA-4E93E0391108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0-096F-4870-9EBA-4E93E0391108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1-096F-4870-9EBA-4E93E0391108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2-096F-4870-9EBA-4E93E0391108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3-096F-4870-9EBA-4E93E0391108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4-096F-4870-9EBA-4E93E039110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rgbClr val="C00000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reg'!$G$2:$G$22</c:f>
              <c:numCache>
                <c:formatCode>0.0</c:formatCode>
                <c:ptCount val="21"/>
                <c:pt idx="0">
                  <c:v>0.32592876705869744</c:v>
                </c:pt>
                <c:pt idx="1">
                  <c:v>1.0140838593934931</c:v>
                </c:pt>
                <c:pt idx="2">
                  <c:v>9.518645549506628</c:v>
                </c:pt>
                <c:pt idx="3">
                  <c:v>3.9272958461622447</c:v>
                </c:pt>
              </c:numCache>
            </c:numRef>
          </c:xVal>
          <c:yVal>
            <c:numRef>
              <c:f>'ForBP-processed_20210528reg'!$H$2:$H$22</c:f>
              <c:numCache>
                <c:formatCode>0.00</c:formatCode>
                <c:ptCount val="21"/>
                <c:pt idx="0">
                  <c:v>0.1434152941001281</c:v>
                </c:pt>
                <c:pt idx="1">
                  <c:v>0.21074753798449353</c:v>
                </c:pt>
                <c:pt idx="2">
                  <c:v>0.19578269002454607</c:v>
                </c:pt>
                <c:pt idx="3">
                  <c:v>0.11705465242478907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reg'!$B$2:$B$22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5-096F-4870-9EBA-4E93E0391108}"/>
            </c:ext>
          </c:extLst>
        </c:ser>
        <c:ser>
          <c:idx val="1"/>
          <c:order val="1"/>
          <c:tx>
            <c:v>C2-PM (1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2400" b="1" i="0" u="none" strike="noStrike" kern="1200" baseline="0">
                        <a:solidFill>
                          <a:srgbClr val="FFC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CCEE58D3-CDE8-40FB-8F84-8FE8E66179DD}" type="CELLRANGE">
                      <a:rPr lang="en-US"/>
                      <a:pPr>
                        <a:defRPr sz="2400" b="1">
                          <a:solidFill>
                            <a:srgbClr val="FFC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2400" b="1" i="0" u="none" strike="noStrike" kern="1200" baseline="0">
                      <a:solidFill>
                        <a:srgbClr val="FFC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6-096F-4870-9EBA-4E93E0391108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FFC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FDF02208-D266-497A-97B1-93B0FD6EFB39}" type="CELLRANGE">
                      <a:rPr lang="en-FI"/>
                      <a:pPr>
                        <a:defRPr sz="1600">
                          <a:solidFill>
                            <a:srgbClr val="FFC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FFC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7-096F-4870-9EBA-4E93E0391108}"/>
                </c:ext>
              </c:extLst>
            </c:dLbl>
            <c:dLbl>
              <c:idx val="2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FFC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9FABC24C-7508-4E52-9FFE-8E8A6E4C4A71}" type="CELLRANGE">
                      <a:rPr lang="en-FI"/>
                      <a:pPr>
                        <a:defRPr sz="1600">
                          <a:solidFill>
                            <a:srgbClr val="FFC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FFC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8-096F-4870-9EBA-4E93E0391108}"/>
                </c:ext>
              </c:extLst>
            </c:dLbl>
            <c:dLbl>
              <c:idx val="3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FFC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467B0AC3-4B72-45B7-B92E-4B4B3F8885CA}" type="CELLRANGE">
                      <a:rPr lang="en-FI"/>
                      <a:pPr>
                        <a:defRPr sz="1600">
                          <a:solidFill>
                            <a:srgbClr val="FFC000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FFC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9-096F-4870-9EBA-4E93E039110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A-096F-4870-9EBA-4E93E039110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B-096F-4870-9EBA-4E93E039110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C-096F-4870-9EBA-4E93E039110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D-096F-4870-9EBA-4E93E039110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E-096F-4870-9EBA-4E93E039110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F-096F-4870-9EBA-4E93E039110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0-096F-4870-9EBA-4E93E039110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1-096F-4870-9EBA-4E93E0391108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2-096F-4870-9EBA-4E93E0391108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3-096F-4870-9EBA-4E93E0391108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4-096F-4870-9EBA-4E93E0391108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5-096F-4870-9EBA-4E93E0391108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6-096F-4870-9EBA-4E93E0391108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7-096F-4870-9EBA-4E93E0391108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8-096F-4870-9EBA-4E93E0391108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9-096F-4870-9EBA-4E93E0391108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A-096F-4870-9EBA-4E93E039110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rgbClr val="FFC000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reg'!$G$23:$G$43</c:f>
              <c:numCache>
                <c:formatCode>0.0</c:formatCode>
                <c:ptCount val="21"/>
                <c:pt idx="0">
                  <c:v>-16.922041693499619</c:v>
                </c:pt>
                <c:pt idx="1">
                  <c:v>-13.008812600220191</c:v>
                </c:pt>
                <c:pt idx="2">
                  <c:v>-15.94676034877534</c:v>
                </c:pt>
                <c:pt idx="3">
                  <c:v>-10.287766893955123</c:v>
                </c:pt>
              </c:numCache>
            </c:numRef>
          </c:xVal>
          <c:yVal>
            <c:numRef>
              <c:f>'ForBP-processed_20210528reg'!$H$23:$H$43</c:f>
              <c:numCache>
                <c:formatCode>0.00</c:formatCode>
                <c:ptCount val="21"/>
                <c:pt idx="0">
                  <c:v>0.11529690375076851</c:v>
                </c:pt>
                <c:pt idx="1">
                  <c:v>0.18980600232612754</c:v>
                </c:pt>
                <c:pt idx="2">
                  <c:v>0.10546942747440846</c:v>
                </c:pt>
                <c:pt idx="3">
                  <c:v>8.2371814199637017E-2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reg'!$B$23:$B$43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2B-096F-4870-9EBA-4E93E0391108}"/>
            </c:ext>
          </c:extLst>
        </c:ser>
        <c:ser>
          <c:idx val="2"/>
          <c:order val="2"/>
          <c:tx>
            <c:v>FQ-PM (1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2400" b="1" i="0" u="none" strike="noStrike" kern="1200" baseline="0">
                        <a:solidFill>
                          <a:srgbClr val="00823B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D9AEA4F8-07D5-4765-9B03-42210D6195FE}" type="CELLRANGE">
                      <a:rPr lang="en-US"/>
                      <a:pPr>
                        <a:defRPr sz="2400" b="1">
                          <a:solidFill>
                            <a:srgbClr val="00823B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2400" b="1" i="0" u="none" strike="noStrike" kern="1200" baseline="0">
                      <a:solidFill>
                        <a:srgbClr val="00823B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2C-096F-4870-9EBA-4E93E0391108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00823B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C9A897B1-255C-407A-8621-42289C3F817A}" type="CELLRANGE">
                      <a:rPr lang="en-FI"/>
                      <a:pPr>
                        <a:defRPr sz="1600">
                          <a:solidFill>
                            <a:srgbClr val="00823B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00823B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D-096F-4870-9EBA-4E93E0391108}"/>
                </c:ext>
              </c:extLst>
            </c:dLbl>
            <c:dLbl>
              <c:idx val="2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00823B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2488E4F1-197D-4B0D-BC24-1B299E250438}" type="CELLRANGE">
                      <a:rPr lang="en-FI"/>
                      <a:pPr>
                        <a:defRPr sz="1600">
                          <a:solidFill>
                            <a:srgbClr val="00823B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00823B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E-096F-4870-9EBA-4E93E0391108}"/>
                </c:ext>
              </c:extLst>
            </c:dLbl>
            <c:dLbl>
              <c:idx val="3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rgbClr val="00823B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6F8B8158-70C8-40DE-94F6-4A96D80286A8}" type="CELLRANGE">
                      <a:rPr lang="en-FI"/>
                      <a:pPr>
                        <a:defRPr sz="1600">
                          <a:solidFill>
                            <a:srgbClr val="00823B"/>
                          </a:solidFill>
                        </a:defRPr>
                      </a:pPr>
                      <a:t>[CELLRANGE]</a:t>
                    </a:fld>
                    <a:endParaRPr lang="en-FI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rgbClr val="00823B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FI"/>
                </a:p>
              </c:txPr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F-096F-4870-9EBA-4E93E0391108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0-096F-4870-9EBA-4E93E0391108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1-096F-4870-9EBA-4E93E0391108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2-096F-4870-9EBA-4E93E0391108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3-096F-4870-9EBA-4E93E0391108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4-096F-4870-9EBA-4E93E0391108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5-096F-4870-9EBA-4E93E0391108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6-096F-4870-9EBA-4E93E0391108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7-096F-4870-9EBA-4E93E0391108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8-096F-4870-9EBA-4E93E0391108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9-096F-4870-9EBA-4E93E0391108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A-096F-4870-9EBA-4E93E0391108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B-096F-4870-9EBA-4E93E0391108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C-096F-4870-9EBA-4E93E0391108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D-096F-4870-9EBA-4E93E0391108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E-096F-4870-9EBA-4E93E0391108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3F-096F-4870-9EBA-4E93E0391108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40-096F-4870-9EBA-4E93E039110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rgbClr val="00823B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reg'!$G$44:$G$64</c:f>
              <c:numCache>
                <c:formatCode>0.0</c:formatCode>
                <c:ptCount val="21"/>
                <c:pt idx="0">
                  <c:v>-17.247970460558314</c:v>
                </c:pt>
                <c:pt idx="1">
                  <c:v>-14.022896459613685</c:v>
                </c:pt>
                <c:pt idx="2">
                  <c:v>-25.465405898281968</c:v>
                </c:pt>
                <c:pt idx="3">
                  <c:v>-14.215062740117368</c:v>
                </c:pt>
              </c:numCache>
            </c:numRef>
          </c:xVal>
          <c:yVal>
            <c:numRef>
              <c:f>'ForBP-processed_20210528reg'!$H$44:$H$64</c:f>
              <c:numCache>
                <c:formatCode>0.00</c:formatCode>
                <c:ptCount val="21"/>
                <c:pt idx="0">
                  <c:v>0.17154672312189467</c:v>
                </c:pt>
                <c:pt idx="1">
                  <c:v>0.19823208033111128</c:v>
                </c:pt>
                <c:pt idx="2">
                  <c:v>0.25532127404180693</c:v>
                </c:pt>
                <c:pt idx="3">
                  <c:v>0.16682117289658527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reg'!$B$44:$B$64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41-096F-4870-9EBA-4E93E0391108}"/>
            </c:ext>
          </c:extLst>
        </c:ser>
        <c:ser>
          <c:idx val="3"/>
          <c:order val="3"/>
          <c:tx>
            <c:v>C2-PM (2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elete val="1"/>
          </c:dLbls>
          <c:xVal>
            <c:numRef>
              <c:f>'ForBP-processed_20210528reg'!$G$65:$G$85</c:f>
              <c:numCache>
                <c:formatCode>0.0</c:formatCode>
                <c:ptCount val="21"/>
                <c:pt idx="0">
                  <c:v>-16.049085872547792</c:v>
                </c:pt>
                <c:pt idx="1">
                  <c:v>-13.361947218410833</c:v>
                </c:pt>
                <c:pt idx="2">
                  <c:v>-12.395339111277616</c:v>
                </c:pt>
                <c:pt idx="3">
                  <c:v>-18.306355826756707</c:v>
                </c:pt>
                <c:pt idx="4">
                  <c:v>-3.4893964034047507</c:v>
                </c:pt>
                <c:pt idx="5">
                  <c:v>-46.13691774457002</c:v>
                </c:pt>
                <c:pt idx="6">
                  <c:v>-33.691516809384026</c:v>
                </c:pt>
                <c:pt idx="7">
                  <c:v>-13.742078881562891</c:v>
                </c:pt>
                <c:pt idx="8">
                  <c:v>-16.024024843817571</c:v>
                </c:pt>
                <c:pt idx="9">
                  <c:v>-6.7008445230508276</c:v>
                </c:pt>
                <c:pt idx="10">
                  <c:v>1.6367233191928738</c:v>
                </c:pt>
                <c:pt idx="11">
                  <c:v>-14.9601280632751</c:v>
                </c:pt>
                <c:pt idx="12">
                  <c:v>-18.076616629732047</c:v>
                </c:pt>
                <c:pt idx="13">
                  <c:v>-4.0071835480601541</c:v>
                </c:pt>
                <c:pt idx="14">
                  <c:v>-10.491565985567302</c:v>
                </c:pt>
                <c:pt idx="15">
                  <c:v>-4.216226041323722</c:v>
                </c:pt>
                <c:pt idx="16">
                  <c:v>4.7014051119887004</c:v>
                </c:pt>
                <c:pt idx="17">
                  <c:v>-9.7040087000592514</c:v>
                </c:pt>
                <c:pt idx="18">
                  <c:v>-0.15791674217326646</c:v>
                </c:pt>
                <c:pt idx="19">
                  <c:v>2.4830867519723414</c:v>
                </c:pt>
                <c:pt idx="20">
                  <c:v>0.80522891351604808</c:v>
                </c:pt>
              </c:numCache>
            </c:numRef>
          </c:xVal>
          <c:yVal>
            <c:numRef>
              <c:f>'ForBP-processed_20210528reg'!$H$65:$H$85</c:f>
              <c:numCache>
                <c:formatCode>0.00</c:formatCode>
                <c:ptCount val="21"/>
                <c:pt idx="0">
                  <c:v>0.15746270237477489</c:v>
                </c:pt>
                <c:pt idx="1">
                  <c:v>0.29329342361213018</c:v>
                </c:pt>
                <c:pt idx="2">
                  <c:v>0.10217358319941205</c:v>
                </c:pt>
                <c:pt idx="3">
                  <c:v>0.17439215916577633</c:v>
                </c:pt>
                <c:pt idx="4">
                  <c:v>0.11924440710770945</c:v>
                </c:pt>
                <c:pt idx="5">
                  <c:v>0.46194208923471458</c:v>
                </c:pt>
                <c:pt idx="6">
                  <c:v>0.36179095424326113</c:v>
                </c:pt>
                <c:pt idx="7">
                  <c:v>0.15052587826536024</c:v>
                </c:pt>
                <c:pt idx="8">
                  <c:v>0.14566719198338118</c:v>
                </c:pt>
                <c:pt idx="9">
                  <c:v>0.12608864886351889</c:v>
                </c:pt>
                <c:pt idx="10">
                  <c:v>0.11376999670965837</c:v>
                </c:pt>
                <c:pt idx="11">
                  <c:v>0.22435672441895405</c:v>
                </c:pt>
                <c:pt idx="12">
                  <c:v>0.27184522219509932</c:v>
                </c:pt>
                <c:pt idx="13">
                  <c:v>0.1642161277175006</c:v>
                </c:pt>
                <c:pt idx="14">
                  <c:v>0.13109171628668825</c:v>
                </c:pt>
                <c:pt idx="15">
                  <c:v>9.2184943865580626E-2</c:v>
                </c:pt>
                <c:pt idx="16">
                  <c:v>0.12055428005271163</c:v>
                </c:pt>
                <c:pt idx="17">
                  <c:v>0.47719745471094566</c:v>
                </c:pt>
                <c:pt idx="18">
                  <c:v>0.55187679105508813</c:v>
                </c:pt>
                <c:pt idx="19">
                  <c:v>0.13671023455106457</c:v>
                </c:pt>
                <c:pt idx="20">
                  <c:v>0.297430757500147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42-096F-4870-9EBA-4E93E039110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axId val="459769256"/>
        <c:axId val="459770824"/>
      </c:scatterChart>
      <c:valAx>
        <c:axId val="459769256"/>
        <c:scaling>
          <c:orientation val="minMax"/>
          <c:max val="35"/>
          <c:min val="-3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59770824"/>
        <c:crosses val="autoZero"/>
        <c:crossBetween val="midCat"/>
        <c:majorUnit val="5"/>
      </c:valAx>
      <c:valAx>
        <c:axId val="459770824"/>
        <c:scaling>
          <c:orientation val="minMax"/>
          <c:max val="0.4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59769256"/>
        <c:crossesAt val="0"/>
        <c:crossBetween val="midCat"/>
        <c:majorUnit val="5.000000000000001E-2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C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FFC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00823B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052191080180805E-2"/>
          <c:y val="3.5325420951787735E-2"/>
          <c:w val="0.82847718212377386"/>
          <c:h val="0.88222467462418441"/>
        </c:manualLayout>
      </c:layout>
      <c:scatterChart>
        <c:scatterStyle val="lineMarker"/>
        <c:varyColors val="0"/>
        <c:ser>
          <c:idx val="0"/>
          <c:order val="0"/>
          <c:tx>
            <c:v>C2-FQ (1TCM)</c:v>
          </c:tx>
          <c:spPr>
            <a:ln w="28575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/>
                  <a:lstStyle/>
                  <a:p>
                    <a:fld id="{6C9ECD01-5CDF-40EF-AC2C-38838B5D50CA}" type="CELLRANGE">
                      <a:rPr lang="en-US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B1C5-44D6-B31C-26F12E1EF76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B1C5-44D6-B31C-26F12E1EF76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B1C5-44D6-B31C-26F12E1EF76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B1C5-44D6-B31C-26F12E1EF7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6BA69AD6-86A6-4A63-A3A1-18C0502C9FB0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4-B1C5-44D6-B31C-26F12E1EF76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52A7485E-D5AE-4E72-9A18-7FE3E9FF6F44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5-B1C5-44D6-B31C-26F12E1EF766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176DC434-774D-4ADB-B1B0-282ADF4C04B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6-B1C5-44D6-B31C-26F12E1EF766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2DFA40EF-FD27-4116-9B7B-D3C57095E4FB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B1C5-44D6-B31C-26F12E1EF766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D35363BC-F73A-4F6B-B9F1-595FD927B9C0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8-B1C5-44D6-B31C-26F12E1EF766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77673645-CCF4-4F30-ADAA-E214D2ACB958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9-B1C5-44D6-B31C-26F12E1EF766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268110DA-7AD3-49E7-A3DD-714073586B6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A-B1C5-44D6-B31C-26F12E1EF766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C53FB6BF-647C-477F-99ED-10EA009D8C3F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B-B1C5-44D6-B31C-26F12E1EF766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AD34D5F8-5D9F-4E56-BC1B-F57839200DB0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C-B1C5-44D6-B31C-26F12E1EF766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EB3B20D2-3F5A-40F6-9FB7-BC044E9F23BA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D-B1C5-44D6-B31C-26F12E1EF766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E25F709C-4928-452C-B727-F9CBC13F317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E-B1C5-44D6-B31C-26F12E1EF766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5DFA356E-B08F-4E26-89F2-461BDD1CEB82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F-B1C5-44D6-B31C-26F12E1EF766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7A01D694-FE56-4541-A499-4472F17E4915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0-B1C5-44D6-B31C-26F12E1EF766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9DE7BD2C-5D4B-4776-8373-82FB2CE29D7E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1-B1C5-44D6-B31C-26F12E1EF766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fld id="{DB7112A1-F678-444F-A0CE-D54FECD7EF7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2-B1C5-44D6-B31C-26F12E1EF766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fld id="{BA2C0DF6-BF97-49A1-AF28-EB63516DB4CE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3-B1C5-44D6-B31C-26F12E1EF766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fld id="{550D5C07-640F-43CF-917D-D08E6E5CF7BB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4-B1C5-44D6-B31C-26F12E1EF7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rgbClr val="C00000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seg'!$G$2:$G$22</c:f>
              <c:numCache>
                <c:formatCode>General</c:formatCode>
                <c:ptCount val="21"/>
                <c:pt idx="4" formatCode="0.0">
                  <c:v>6.5089177941035663</c:v>
                </c:pt>
                <c:pt idx="5" formatCode="0.0">
                  <c:v>9.8508863914372782</c:v>
                </c:pt>
                <c:pt idx="6" formatCode="0.0">
                  <c:v>7.5473284058773791</c:v>
                </c:pt>
                <c:pt idx="7" formatCode="0.0">
                  <c:v>0.19811406106462615</c:v>
                </c:pt>
                <c:pt idx="8" formatCode="0.0">
                  <c:v>15.97408665762125</c:v>
                </c:pt>
                <c:pt idx="9" formatCode="0.0">
                  <c:v>10.329972423071547</c:v>
                </c:pt>
                <c:pt idx="10" formatCode="0.0">
                  <c:v>17.386998914253752</c:v>
                </c:pt>
                <c:pt idx="11" formatCode="0.0">
                  <c:v>14.285436431334512</c:v>
                </c:pt>
                <c:pt idx="12" formatCode="0.0">
                  <c:v>5.2828884050189533</c:v>
                </c:pt>
                <c:pt idx="13" formatCode="0.0">
                  <c:v>7.9618700850410287</c:v>
                </c:pt>
                <c:pt idx="14" formatCode="0.0">
                  <c:v>16.719673640421892</c:v>
                </c:pt>
                <c:pt idx="15" formatCode="0.0">
                  <c:v>12.797965941073491</c:v>
                </c:pt>
                <c:pt idx="16" formatCode="0.0">
                  <c:v>4.1941434066241259</c:v>
                </c:pt>
                <c:pt idx="17" formatCode="0.0">
                  <c:v>10.295746448254448</c:v>
                </c:pt>
                <c:pt idx="18" formatCode="0.0">
                  <c:v>9.5889719131790887</c:v>
                </c:pt>
                <c:pt idx="19" formatCode="0.0">
                  <c:v>5.7921794362567489</c:v>
                </c:pt>
                <c:pt idx="20" formatCode="0.0">
                  <c:v>3.3731862485816904</c:v>
                </c:pt>
              </c:numCache>
            </c:numRef>
          </c:xVal>
          <c:yVal>
            <c:numRef>
              <c:f>'ForBP-processed_20210528seg'!$H$2:$H$22</c:f>
              <c:numCache>
                <c:formatCode>General</c:formatCode>
                <c:ptCount val="21"/>
                <c:pt idx="4" formatCode="0.00">
                  <c:v>0.21897111211538767</c:v>
                </c:pt>
                <c:pt idx="5" formatCode="0.00">
                  <c:v>0.17905600678404243</c:v>
                </c:pt>
                <c:pt idx="6" formatCode="0.00">
                  <c:v>0.20336523708986431</c:v>
                </c:pt>
                <c:pt idx="7" formatCode="0.00">
                  <c:v>0.16065061997300301</c:v>
                </c:pt>
                <c:pt idx="8" formatCode="0.00">
                  <c:v>0.28457451054925154</c:v>
                </c:pt>
                <c:pt idx="9" formatCode="0.00">
                  <c:v>0.24458170241137811</c:v>
                </c:pt>
                <c:pt idx="10" formatCode="0.00">
                  <c:v>0.19540979664684011</c:v>
                </c:pt>
                <c:pt idx="11" formatCode="0.00">
                  <c:v>0.20360534929851615</c:v>
                </c:pt>
                <c:pt idx="12" formatCode="0.00">
                  <c:v>0.16984659582236139</c:v>
                </c:pt>
                <c:pt idx="13" formatCode="0.00">
                  <c:v>0.14703029621307295</c:v>
                </c:pt>
                <c:pt idx="14" formatCode="0.00">
                  <c:v>0.27310680628882444</c:v>
                </c:pt>
                <c:pt idx="15" formatCode="0.00">
                  <c:v>0.23398590955332399</c:v>
                </c:pt>
                <c:pt idx="16" formatCode="0.00">
                  <c:v>0.1754554092338082</c:v>
                </c:pt>
                <c:pt idx="17" formatCode="0.00">
                  <c:v>0.17702282839350614</c:v>
                </c:pt>
                <c:pt idx="18" formatCode="0.00">
                  <c:v>0.14718371742010639</c:v>
                </c:pt>
                <c:pt idx="19" formatCode="0.00">
                  <c:v>0.23065171374252413</c:v>
                </c:pt>
                <c:pt idx="20" formatCode="0.00">
                  <c:v>0.22601508745849652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seg'!$B$2:$B$22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5-B1C5-44D6-B31C-26F12E1EF766}"/>
            </c:ext>
          </c:extLst>
        </c:ser>
        <c:ser>
          <c:idx val="1"/>
          <c:order val="1"/>
          <c:tx>
            <c:v>C2-PM (1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/>
                  <a:lstStyle/>
                  <a:p>
                    <a:fld id="{40145D15-7BF9-4A99-875D-BF0A9FED3E2F}" type="CELLRANGE">
                      <a:rPr lang="en-US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6-B1C5-44D6-B31C-26F12E1EF76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7-B1C5-44D6-B31C-26F12E1EF76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8-B1C5-44D6-B31C-26F12E1EF76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9-B1C5-44D6-B31C-26F12E1EF7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FDA43AB7-4AE1-441B-8648-7DE8C92F0DFD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A-B1C5-44D6-B31C-26F12E1EF76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8B1EAA44-ECCA-44DD-8A26-01F87BA2217F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B-B1C5-44D6-B31C-26F12E1EF766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4C69A1CF-DF42-4466-970B-626C7A15036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C-B1C5-44D6-B31C-26F12E1EF766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253AFA9E-C69B-40C6-BE5F-7ECFD4468727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D-B1C5-44D6-B31C-26F12E1EF766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023C201C-3E95-43CF-81DB-04F68509259B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E-B1C5-44D6-B31C-26F12E1EF766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D026CF5D-3E1B-43E2-89D6-7A5A84025D5A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1F-B1C5-44D6-B31C-26F12E1EF766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3A466631-F2CD-4F6F-96AB-63F3D2E85BA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0-B1C5-44D6-B31C-26F12E1EF766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79F21A3F-B3A4-41B3-A00C-B1C7237840B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1-B1C5-44D6-B31C-26F12E1EF766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56D9B288-00E7-4F1A-B672-67A4143DC577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2-B1C5-44D6-B31C-26F12E1EF766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A81DB662-7803-4B72-B1F4-F42736FC3C46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3-B1C5-44D6-B31C-26F12E1EF766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8498CB7B-2EB3-4500-814B-DBB1D21831B2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4-B1C5-44D6-B31C-26F12E1EF766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EFDEA98B-49DE-4915-ABB4-8E0BF8203A2F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5-B1C5-44D6-B31C-26F12E1EF766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E92324E0-7266-42D0-8F76-7283475A0A88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6-B1C5-44D6-B31C-26F12E1EF766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2DBCCE3B-B34E-4593-8270-03A272EC86AC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7-B1C5-44D6-B31C-26F12E1EF766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fld id="{56A31AF3-741C-4A64-8EA4-80E70C03C50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8-B1C5-44D6-B31C-26F12E1EF766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fld id="{D222425E-0D93-48BC-87FA-E161FDCCBA5E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9-B1C5-44D6-B31C-26F12E1EF766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fld id="{AE1DB0B6-65A5-4E34-B34C-7282D5F2C2F1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2A-B1C5-44D6-B31C-26F12E1EF7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rgbClr val="FFC000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seg'!$G$23:$G$43</c:f>
              <c:numCache>
                <c:formatCode>General</c:formatCode>
                <c:ptCount val="21"/>
                <c:pt idx="4" formatCode="0.0">
                  <c:v>-8.9220590633619228</c:v>
                </c:pt>
                <c:pt idx="5" formatCode="0.0">
                  <c:v>-10.507423518407837</c:v>
                </c:pt>
                <c:pt idx="6" formatCode="0.0">
                  <c:v>-7.235356245916738</c:v>
                </c:pt>
                <c:pt idx="7" formatCode="0.0">
                  <c:v>-14.653613726939598</c:v>
                </c:pt>
                <c:pt idx="8" formatCode="0.0">
                  <c:v>-16.403221900589813</c:v>
                </c:pt>
                <c:pt idx="9" formatCode="0.0">
                  <c:v>-16.098383956941738</c:v>
                </c:pt>
                <c:pt idx="10" formatCode="0.0">
                  <c:v>3.6058175286305234</c:v>
                </c:pt>
                <c:pt idx="11" formatCode="0.0">
                  <c:v>-0.81072211442084152</c:v>
                </c:pt>
                <c:pt idx="12" formatCode="0.0">
                  <c:v>-10.258878068995095</c:v>
                </c:pt>
                <c:pt idx="13" formatCode="0.0">
                  <c:v>-1.9981028801248975</c:v>
                </c:pt>
                <c:pt idx="14" formatCode="0.0">
                  <c:v>-10.687908261474989</c:v>
                </c:pt>
                <c:pt idx="15" formatCode="0.0">
                  <c:v>-6.5511539584627281</c:v>
                </c:pt>
                <c:pt idx="16" formatCode="0.0">
                  <c:v>3.2494055497067742</c:v>
                </c:pt>
                <c:pt idx="17" formatCode="0.0">
                  <c:v>1.1165117464837626</c:v>
                </c:pt>
                <c:pt idx="18" formatCode="0.0">
                  <c:v>-1.018831991949402</c:v>
                </c:pt>
                <c:pt idx="19" formatCode="0.0">
                  <c:v>-2.3548719085016607</c:v>
                </c:pt>
                <c:pt idx="20" formatCode="0.0">
                  <c:v>-3.0558467401942151</c:v>
                </c:pt>
              </c:numCache>
            </c:numRef>
          </c:xVal>
          <c:yVal>
            <c:numRef>
              <c:f>'ForBP-processed_20210528seg'!$H$23:$H$43</c:f>
              <c:numCache>
                <c:formatCode>General</c:formatCode>
                <c:ptCount val="21"/>
                <c:pt idx="4" formatCode="0.00">
                  <c:v>0.14441851047831089</c:v>
                </c:pt>
                <c:pt idx="5" formatCode="0.00">
                  <c:v>0.12429361147304385</c:v>
                </c:pt>
                <c:pt idx="6" formatCode="0.00">
                  <c:v>0.11715216639588333</c:v>
                </c:pt>
                <c:pt idx="7" formatCode="0.00">
                  <c:v>0.12785403025597064</c:v>
                </c:pt>
                <c:pt idx="8" formatCode="0.00">
                  <c:v>0.15596709554362309</c:v>
                </c:pt>
                <c:pt idx="9" formatCode="0.00">
                  <c:v>9.2501757975822829E-2</c:v>
                </c:pt>
                <c:pt idx="10" formatCode="0.00">
                  <c:v>0.11701062734659118</c:v>
                </c:pt>
                <c:pt idx="11" formatCode="0.00">
                  <c:v>9.9279273583035677E-2</c:v>
                </c:pt>
                <c:pt idx="12" formatCode="0.00">
                  <c:v>0.1025413604837736</c:v>
                </c:pt>
                <c:pt idx="13" formatCode="0.00">
                  <c:v>0.12840535843430467</c:v>
                </c:pt>
                <c:pt idx="14" formatCode="0.00">
                  <c:v>0.10256982151829153</c:v>
                </c:pt>
                <c:pt idx="15" formatCode="0.00">
                  <c:v>0.11819976190063308</c:v>
                </c:pt>
                <c:pt idx="16" formatCode="0.00">
                  <c:v>0.12274066566849207</c:v>
                </c:pt>
                <c:pt idx="17" formatCode="0.00">
                  <c:v>0.10494898015869902</c:v>
                </c:pt>
                <c:pt idx="18" formatCode="0.00">
                  <c:v>8.3264294919939252E-2</c:v>
                </c:pt>
                <c:pt idx="19" formatCode="0.00">
                  <c:v>0.13353066959288817</c:v>
                </c:pt>
                <c:pt idx="20" formatCode="0.00">
                  <c:v>9.6288923532201198E-2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seg'!$B$23:$B$43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2B-B1C5-44D6-B31C-26F12E1EF766}"/>
            </c:ext>
          </c:extLst>
        </c:ser>
        <c:ser>
          <c:idx val="2"/>
          <c:order val="2"/>
          <c:tx>
            <c:v>FQ-PM (1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Lbl>
              <c:idx val="0"/>
              <c:tx>
                <c:rich>
                  <a:bodyPr/>
                  <a:lstStyle/>
                  <a:p>
                    <a:fld id="{654C0347-85D0-4C27-A194-53C1F6610329}" type="CELLRANGE">
                      <a:rPr lang="en-US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2C-B1C5-44D6-B31C-26F12E1EF766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D-B1C5-44D6-B31C-26F12E1EF766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E-B1C5-44D6-B31C-26F12E1EF766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endParaRPr lang="fi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2F-B1C5-44D6-B31C-26F12E1EF766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012B5DD0-C7B6-49F8-92E8-38C7246A686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0-B1C5-44D6-B31C-26F12E1EF766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8998854E-5945-4D83-BEA5-3E842832C495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1-B1C5-44D6-B31C-26F12E1EF766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CFCBDE4A-17B7-44E3-980E-FF8D910EAFA0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2-B1C5-44D6-B31C-26F12E1EF766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6FA2C50F-E438-410C-B95B-B8E48AA6D885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3-B1C5-44D6-B31C-26F12E1EF766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7E14A86A-6E93-494B-B6BB-E299C9618746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4-B1C5-44D6-B31C-26F12E1EF766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56DAA0A5-4E24-41C1-B48E-71091D892F89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5-B1C5-44D6-B31C-26F12E1EF766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D40C15C6-2F89-4969-8321-FCA78D5CED6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6-B1C5-44D6-B31C-26F12E1EF766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4EF8EFFE-420C-437F-823C-5926ECE28A64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7-B1C5-44D6-B31C-26F12E1EF766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FAB8EC2E-8A37-498E-A115-93D5E3F58470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8-B1C5-44D6-B31C-26F12E1EF766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EC032F4F-B32C-424D-A9A5-11237010426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9-B1C5-44D6-B31C-26F12E1EF766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FF9FAC89-332A-47A7-8BE8-422093795683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A-B1C5-44D6-B31C-26F12E1EF766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77825ACF-F896-4E9E-A06E-31424A5590D2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B-B1C5-44D6-B31C-26F12E1EF766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EC18E9F2-4DA3-4918-A970-E93DBA0F11A2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C-B1C5-44D6-B31C-26F12E1EF766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EF2363F4-F0BA-4EE2-A9DC-83F23694DC97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D-B1C5-44D6-B31C-26F12E1EF766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fld id="{D37F22FD-73CF-43CE-88BA-611BE334B501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E-B1C5-44D6-B31C-26F12E1EF766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fld id="{8A0723C4-C686-45AA-9410-EDFA27DC262E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3F-B1C5-44D6-B31C-26F12E1EF766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fld id="{A8542B4C-5CE4-4C8F-B2FA-EC65A460F62A}" type="CELLRANGE">
                      <a:rPr lang="en-FI"/>
                      <a:pPr/>
                      <a:t>[CELLRANGE]</a:t>
                    </a:fld>
                    <a:endParaRPr lang="en-FI"/>
                  </a:p>
                </c:rich>
              </c:tx>
              <c:dLblPos val="ct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40-B1C5-44D6-B31C-26F12E1EF76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rgbClr val="00823B"/>
                    </a:solidFill>
                    <a:latin typeface="+mn-lt"/>
                    <a:ea typeface="+mn-ea"/>
                    <a:cs typeface="+mn-cs"/>
                  </a:defRPr>
                </a:pPr>
                <a:endParaRPr lang="en-FI"/>
              </a:p>
            </c:txPr>
            <c:dLblPos val="ctr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ForBP-processed_20210528seg'!$G$44:$G$64</c:f>
              <c:numCache>
                <c:formatCode>General</c:formatCode>
                <c:ptCount val="21"/>
                <c:pt idx="4" formatCode="0.0">
                  <c:v>-15.43097685746549</c:v>
                </c:pt>
                <c:pt idx="5" formatCode="0.0">
                  <c:v>-20.358309909845115</c:v>
                </c:pt>
                <c:pt idx="6" formatCode="0.0">
                  <c:v>-14.782684651794117</c:v>
                </c:pt>
                <c:pt idx="7" formatCode="0.0">
                  <c:v>-14.851727788004226</c:v>
                </c:pt>
                <c:pt idx="8" formatCode="0.0">
                  <c:v>-32.377308558211062</c:v>
                </c:pt>
                <c:pt idx="9" formatCode="0.0">
                  <c:v>-26.428356380013284</c:v>
                </c:pt>
                <c:pt idx="10" formatCode="0.0">
                  <c:v>-13.781181385623226</c:v>
                </c:pt>
                <c:pt idx="11" formatCode="0.0">
                  <c:v>-15.096158545755353</c:v>
                </c:pt>
                <c:pt idx="12" formatCode="0.0">
                  <c:v>-15.541766474014048</c:v>
                </c:pt>
                <c:pt idx="13" formatCode="0.0">
                  <c:v>-9.9599729651659263</c:v>
                </c:pt>
                <c:pt idx="14" formatCode="0.0">
                  <c:v>-27.407581901896883</c:v>
                </c:pt>
                <c:pt idx="15" formatCode="0.0">
                  <c:v>-19.34911989953622</c:v>
                </c:pt>
                <c:pt idx="16" formatCode="0.0">
                  <c:v>-0.94473785691735168</c:v>
                </c:pt>
                <c:pt idx="17" formatCode="0.0">
                  <c:v>-9.1792347017706852</c:v>
                </c:pt>
                <c:pt idx="18" formatCode="0.0">
                  <c:v>-10.60780390512849</c:v>
                </c:pt>
                <c:pt idx="19" formatCode="0.0">
                  <c:v>-8.1470513447584096</c:v>
                </c:pt>
                <c:pt idx="20" formatCode="0.0">
                  <c:v>-6.429032988775905</c:v>
                </c:pt>
              </c:numCache>
            </c:numRef>
          </c:xVal>
          <c:yVal>
            <c:numRef>
              <c:f>'ForBP-processed_20210528seg'!$H$44:$H$64</c:f>
              <c:numCache>
                <c:formatCode>General</c:formatCode>
                <c:ptCount val="21"/>
                <c:pt idx="4" formatCode="0.00">
                  <c:v>0.41491676606844607</c:v>
                </c:pt>
                <c:pt idx="5" formatCode="0.00">
                  <c:v>0.30435331102113472</c:v>
                </c:pt>
                <c:pt idx="6" formatCode="0.00">
                  <c:v>0.2664609844670851</c:v>
                </c:pt>
                <c:pt idx="7" formatCode="0.00">
                  <c:v>0.19795856588518512</c:v>
                </c:pt>
                <c:pt idx="8" formatCode="0.00">
                  <c:v>0.38638320552425287</c:v>
                </c:pt>
                <c:pt idx="9" formatCode="0.00">
                  <c:v>0.31401312370830192</c:v>
                </c:pt>
                <c:pt idx="10" formatCode="0.00">
                  <c:v>0.24759221273987675</c:v>
                </c:pt>
                <c:pt idx="11" formatCode="0.00">
                  <c:v>0.27676585260817232</c:v>
                </c:pt>
                <c:pt idx="12" formatCode="0.00">
                  <c:v>0.26795395941275058</c:v>
                </c:pt>
                <c:pt idx="13" formatCode="0.00">
                  <c:v>0.2620684314538162</c:v>
                </c:pt>
                <c:pt idx="14" formatCode="0.00">
                  <c:v>0.33151050801635873</c:v>
                </c:pt>
                <c:pt idx="15" formatCode="0.00">
                  <c:v>0.2318154092591459</c:v>
                </c:pt>
                <c:pt idx="16" formatCode="0.00">
                  <c:v>0.18366871152070352</c:v>
                </c:pt>
                <c:pt idx="17" formatCode="0.00">
                  <c:v>0.17200027468964352</c:v>
                </c:pt>
                <c:pt idx="18" formatCode="0.00">
                  <c:v>0.17084043286570794</c:v>
                </c:pt>
                <c:pt idx="19" formatCode="0.00">
                  <c:v>0.20269763764916338</c:v>
                </c:pt>
                <c:pt idx="20" formatCode="0.00">
                  <c:v>0.21365345252541201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ForBP-processed_20210528seg'!$B$44:$B$64</c15:f>
                <c15:dlblRangeCache>
                  <c:ptCount val="21"/>
                  <c:pt idx="0">
                    <c:v>GLO</c:v>
                  </c:pt>
                  <c:pt idx="1">
                    <c:v>LAD</c:v>
                  </c:pt>
                  <c:pt idx="2">
                    <c:v>LCX</c:v>
                  </c:pt>
                  <c:pt idx="3">
                    <c:v>RCA</c:v>
                  </c:pt>
                  <c:pt idx="4">
                    <c:v>s01</c:v>
                  </c:pt>
                  <c:pt idx="5">
                    <c:v>s02</c:v>
                  </c:pt>
                  <c:pt idx="6">
                    <c:v>s03</c:v>
                  </c:pt>
                  <c:pt idx="7">
                    <c:v>s04</c:v>
                  </c:pt>
                  <c:pt idx="8">
                    <c:v>s05</c:v>
                  </c:pt>
                  <c:pt idx="9">
                    <c:v>s06</c:v>
                  </c:pt>
                  <c:pt idx="10">
                    <c:v>s07</c:v>
                  </c:pt>
                  <c:pt idx="11">
                    <c:v>s08</c:v>
                  </c:pt>
                  <c:pt idx="12">
                    <c:v>s09</c:v>
                  </c:pt>
                  <c:pt idx="13">
                    <c:v>s10</c:v>
                  </c:pt>
                  <c:pt idx="14">
                    <c:v>s11</c:v>
                  </c:pt>
                  <c:pt idx="15">
                    <c:v>s12</c:v>
                  </c:pt>
                  <c:pt idx="16">
                    <c:v>s13</c:v>
                  </c:pt>
                  <c:pt idx="17">
                    <c:v>s14</c:v>
                  </c:pt>
                  <c:pt idx="18">
                    <c:v>s15</c:v>
                  </c:pt>
                  <c:pt idx="19">
                    <c:v>s16</c:v>
                  </c:pt>
                  <c:pt idx="20">
                    <c:v>s17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41-B1C5-44D6-B31C-26F12E1EF766}"/>
            </c:ext>
          </c:extLst>
        </c:ser>
        <c:ser>
          <c:idx val="3"/>
          <c:order val="3"/>
          <c:tx>
            <c:v>C2-PM (2TCM)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Lbls>
            <c:delete val="1"/>
          </c:dLbls>
          <c:xVal>
            <c:numRef>
              <c:f>'ForBP-processed_20210528seg'!$G$65:$G$85</c:f>
              <c:numCache>
                <c:formatCode>0.0</c:formatCode>
                <c:ptCount val="21"/>
                <c:pt idx="0">
                  <c:v>-16.049085872547792</c:v>
                </c:pt>
                <c:pt idx="1">
                  <c:v>-13.361947218410833</c:v>
                </c:pt>
                <c:pt idx="2">
                  <c:v>-12.395339111277616</c:v>
                </c:pt>
                <c:pt idx="3">
                  <c:v>-18.306355826756707</c:v>
                </c:pt>
                <c:pt idx="4">
                  <c:v>-3.4893964034047507</c:v>
                </c:pt>
                <c:pt idx="5">
                  <c:v>-46.13691774457002</c:v>
                </c:pt>
                <c:pt idx="6">
                  <c:v>-33.691516809384026</c:v>
                </c:pt>
                <c:pt idx="7">
                  <c:v>-13.742078881562891</c:v>
                </c:pt>
                <c:pt idx="8">
                  <c:v>-16.024024843817571</c:v>
                </c:pt>
                <c:pt idx="9">
                  <c:v>-6.7008445230508276</c:v>
                </c:pt>
                <c:pt idx="10">
                  <c:v>1.6367233191928738</c:v>
                </c:pt>
                <c:pt idx="11">
                  <c:v>-14.9601280632751</c:v>
                </c:pt>
                <c:pt idx="12">
                  <c:v>-18.076616629732047</c:v>
                </c:pt>
                <c:pt idx="13">
                  <c:v>-4.0071835480601541</c:v>
                </c:pt>
                <c:pt idx="14">
                  <c:v>-10.491565985567302</c:v>
                </c:pt>
                <c:pt idx="15">
                  <c:v>-4.216226041323722</c:v>
                </c:pt>
                <c:pt idx="16">
                  <c:v>4.7014051119887004</c:v>
                </c:pt>
                <c:pt idx="17">
                  <c:v>-9.7040087000592514</c:v>
                </c:pt>
                <c:pt idx="18">
                  <c:v>-0.15791674217326646</c:v>
                </c:pt>
                <c:pt idx="19">
                  <c:v>2.4830867519723414</c:v>
                </c:pt>
                <c:pt idx="20">
                  <c:v>0.80522891351604808</c:v>
                </c:pt>
              </c:numCache>
            </c:numRef>
          </c:xVal>
          <c:yVal>
            <c:numRef>
              <c:f>'ForBP-processed_20210528seg'!$H$65:$H$85</c:f>
              <c:numCache>
                <c:formatCode>0.00</c:formatCode>
                <c:ptCount val="21"/>
                <c:pt idx="0">
                  <c:v>0.15746270237477489</c:v>
                </c:pt>
                <c:pt idx="1">
                  <c:v>0.29329342361213018</c:v>
                </c:pt>
                <c:pt idx="2">
                  <c:v>0.10217358319941205</c:v>
                </c:pt>
                <c:pt idx="3">
                  <c:v>0.17439215916577633</c:v>
                </c:pt>
                <c:pt idx="4">
                  <c:v>0.11924440710770945</c:v>
                </c:pt>
                <c:pt idx="5">
                  <c:v>0.46194208923471458</c:v>
                </c:pt>
                <c:pt idx="6">
                  <c:v>0.36179095424326113</c:v>
                </c:pt>
                <c:pt idx="7">
                  <c:v>0.15052587826536024</c:v>
                </c:pt>
                <c:pt idx="8">
                  <c:v>0.14566719198338118</c:v>
                </c:pt>
                <c:pt idx="9">
                  <c:v>0.12608864886351889</c:v>
                </c:pt>
                <c:pt idx="10">
                  <c:v>0.11376999670965837</c:v>
                </c:pt>
                <c:pt idx="11">
                  <c:v>0.22435672441895405</c:v>
                </c:pt>
                <c:pt idx="12">
                  <c:v>0.27184522219509932</c:v>
                </c:pt>
                <c:pt idx="13">
                  <c:v>0.1642161277175006</c:v>
                </c:pt>
                <c:pt idx="14">
                  <c:v>0.13109171628668825</c:v>
                </c:pt>
                <c:pt idx="15">
                  <c:v>9.2184943865580626E-2</c:v>
                </c:pt>
                <c:pt idx="16">
                  <c:v>0.12055428005271163</c:v>
                </c:pt>
                <c:pt idx="17">
                  <c:v>0.47719745471094566</c:v>
                </c:pt>
                <c:pt idx="18">
                  <c:v>0.55187679105508813</c:v>
                </c:pt>
                <c:pt idx="19">
                  <c:v>0.13671023455106457</c:v>
                </c:pt>
                <c:pt idx="20">
                  <c:v>0.297430757500147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42-B1C5-44D6-B31C-26F12E1EF766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axId val="459769256"/>
        <c:axId val="459770824"/>
      </c:scatterChart>
      <c:valAx>
        <c:axId val="459769256"/>
        <c:scaling>
          <c:orientation val="minMax"/>
          <c:max val="35"/>
          <c:min val="-35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59770824"/>
        <c:crosses val="autoZero"/>
        <c:crossBetween val="midCat"/>
        <c:majorUnit val="5"/>
      </c:valAx>
      <c:valAx>
        <c:axId val="459770824"/>
        <c:scaling>
          <c:orientation val="minMax"/>
          <c:max val="0.4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  <c:crossAx val="459769256"/>
        <c:crossesAt val="0"/>
        <c:crossBetween val="midCat"/>
        <c:majorUnit val="5.000000000000001E-2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C00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FFC000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rgbClr val="00823B"/>
                </a:solidFill>
                <a:latin typeface="+mn-lt"/>
                <a:ea typeface="+mn-ea"/>
                <a:cs typeface="+mn-cs"/>
              </a:defRPr>
            </a:pPr>
            <a:endParaRPr lang="en-FI"/>
          </a:p>
        </c:txPr>
      </c:legendEntry>
      <c:legendEntry>
        <c:idx val="3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FI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FI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0831</cdr:x>
      <cdr:y>0.42617</cdr:y>
    </cdr:from>
    <cdr:to>
      <cdr:x>0.68122</cdr:x>
      <cdr:y>0.91605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CB8D823D-C8D5-43CD-9E8B-86D113D2A20D}"/>
            </a:ext>
          </a:extLst>
        </cdr:cNvPr>
        <cdr:cNvSpPr/>
      </cdr:nvSpPr>
      <cdr:spPr>
        <a:xfrm xmlns:a="http://schemas.openxmlformats.org/drawingml/2006/main">
          <a:off x="1645118" y="1888356"/>
          <a:ext cx="3734803" cy="2170698"/>
        </a:xfrm>
        <a:prstGeom xmlns:a="http://schemas.openxmlformats.org/drawingml/2006/main" prst="rect">
          <a:avLst/>
        </a:prstGeom>
        <a:solidFill xmlns:a="http://schemas.openxmlformats.org/drawingml/2006/main">
          <a:srgbClr val="6600FF">
            <a:alpha val="10000"/>
          </a:srgbClr>
        </a:solidFill>
        <a:ln xmlns:a="http://schemas.openxmlformats.org/drawingml/2006/main" w="6350">
          <a:solidFill>
            <a:srgbClr val="6600FF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FI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0822</cdr:x>
      <cdr:y>0.42793</cdr:y>
    </cdr:from>
    <cdr:to>
      <cdr:x>0.68125</cdr:x>
      <cdr:y>0.91697</cdr:y>
    </cdr:to>
    <cdr:sp macro="" textlink="">
      <cdr:nvSpPr>
        <cdr:cNvPr id="2" name="Rectangle 1">
          <a:extLst xmlns:a="http://schemas.openxmlformats.org/drawingml/2006/main">
            <a:ext uri="{FF2B5EF4-FFF2-40B4-BE49-F238E27FC236}">
              <a16:creationId xmlns:a16="http://schemas.microsoft.com/office/drawing/2014/main" id="{6980A749-6071-4B56-B5A5-28F3B9C62DFA}"/>
            </a:ext>
          </a:extLst>
        </cdr:cNvPr>
        <cdr:cNvSpPr/>
      </cdr:nvSpPr>
      <cdr:spPr>
        <a:xfrm xmlns:a="http://schemas.openxmlformats.org/drawingml/2006/main">
          <a:off x="1632585" y="1896189"/>
          <a:ext cx="3708797" cy="2166938"/>
        </a:xfrm>
        <a:prstGeom xmlns:a="http://schemas.openxmlformats.org/drawingml/2006/main" prst="rect">
          <a:avLst/>
        </a:prstGeom>
        <a:solidFill xmlns:a="http://schemas.openxmlformats.org/drawingml/2006/main">
          <a:srgbClr val="6600FF">
            <a:alpha val="10000"/>
          </a:srgbClr>
        </a:solidFill>
        <a:ln xmlns:a="http://schemas.openxmlformats.org/drawingml/2006/main" w="6350">
          <a:solidFill>
            <a:srgbClr val="6600FF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FI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46347" cy="4964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51342" y="0"/>
            <a:ext cx="2946347" cy="4964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9431599"/>
            <a:ext cx="2946347" cy="4964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51342" y="9431599"/>
            <a:ext cx="2946347" cy="4964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7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fi-FI" sz="2000" b="1" dirty="0"/>
              <a:t>One-</a:t>
            </a:r>
            <a:r>
              <a:rPr lang="fi-FI" sz="2000" b="1" dirty="0" err="1"/>
              <a:t>tissue</a:t>
            </a:r>
            <a:r>
              <a:rPr lang="fi-FI" sz="2000" b="1" dirty="0"/>
              <a:t> </a:t>
            </a:r>
            <a:r>
              <a:rPr lang="fi-FI" sz="2000" b="1" dirty="0" err="1"/>
              <a:t>compartment</a:t>
            </a:r>
            <a:r>
              <a:rPr lang="fi-FI" sz="2000" b="1" dirty="0"/>
              <a:t> </a:t>
            </a:r>
            <a:r>
              <a:rPr lang="fi-FI" sz="2000" b="1" dirty="0" err="1"/>
              <a:t>model</a:t>
            </a:r>
            <a:r>
              <a:rPr lang="fi-FI" sz="2000" b="1" dirty="0"/>
              <a:t> for </a:t>
            </a:r>
            <a:r>
              <a:rPr lang="fi-FI" sz="2000" b="1" dirty="0" err="1"/>
              <a:t>myocardial</a:t>
            </a:r>
            <a:r>
              <a:rPr lang="fi-FI" sz="2000" b="1" dirty="0"/>
              <a:t> </a:t>
            </a:r>
            <a:r>
              <a:rPr lang="fi-FI" sz="2000" b="1" dirty="0" err="1"/>
              <a:t>perfusion</a:t>
            </a:r>
            <a:r>
              <a:rPr lang="fi-FI" sz="2000" b="1" dirty="0"/>
              <a:t> </a:t>
            </a:r>
            <a:r>
              <a:rPr lang="fi-FI" sz="2000" b="1" dirty="0" err="1"/>
              <a:t>quantification</a:t>
            </a:r>
            <a:r>
              <a:rPr lang="fi-FI" sz="2000" b="1" dirty="0"/>
              <a:t> </a:t>
            </a:r>
            <a:r>
              <a:rPr lang="fi-FI" sz="2000" b="1" dirty="0" err="1"/>
              <a:t>with</a:t>
            </a:r>
            <a:r>
              <a:rPr lang="fi-FI" sz="2000" b="1" dirty="0"/>
              <a:t> N-13 </a:t>
            </a:r>
            <a:r>
              <a:rPr lang="fi-FI" sz="2000" b="1" dirty="0" err="1"/>
              <a:t>ammonia</a:t>
            </a:r>
            <a:r>
              <a:rPr lang="fi-FI" sz="2000" b="1" dirty="0"/>
              <a:t> PET </a:t>
            </a:r>
            <a:r>
              <a:rPr lang="fi-FI" sz="2000" b="1" dirty="0" err="1"/>
              <a:t>provides</a:t>
            </a:r>
            <a:r>
              <a:rPr lang="fi-FI" sz="2000" b="1" dirty="0"/>
              <a:t> </a:t>
            </a:r>
            <a:r>
              <a:rPr lang="fi-FI" sz="2000" b="1" dirty="0" err="1"/>
              <a:t>matching</a:t>
            </a:r>
            <a:r>
              <a:rPr lang="fi-FI" sz="2000" b="1" dirty="0"/>
              <a:t> </a:t>
            </a:r>
            <a:r>
              <a:rPr lang="fi-FI" sz="2000" b="1" dirty="0" err="1"/>
              <a:t>results</a:t>
            </a:r>
            <a:r>
              <a:rPr lang="fi-FI" sz="2000" b="1" dirty="0"/>
              <a:t>—a  cross-</a:t>
            </a:r>
            <a:r>
              <a:rPr lang="fi-FI" sz="2000" b="1" dirty="0" err="1"/>
              <a:t>comparison</a:t>
            </a:r>
            <a:r>
              <a:rPr lang="fi-FI" sz="2000" b="1" dirty="0"/>
              <a:t> </a:t>
            </a:r>
            <a:r>
              <a:rPr lang="fi-FI" sz="2000" b="1" dirty="0" err="1"/>
              <a:t>between</a:t>
            </a:r>
            <a:r>
              <a:rPr lang="fi-FI" sz="2000" b="1" dirty="0"/>
              <a:t> </a:t>
            </a:r>
            <a:r>
              <a:rPr lang="fi-FI" sz="2000" b="1" dirty="0" err="1"/>
              <a:t>Carimas</a:t>
            </a:r>
            <a:r>
              <a:rPr lang="fi-FI" sz="2000" b="1" dirty="0"/>
              <a:t>, </a:t>
            </a:r>
            <a:r>
              <a:rPr lang="fi-FI" sz="2000" b="1" dirty="0" err="1"/>
              <a:t>FlowQuant</a:t>
            </a:r>
            <a:r>
              <a:rPr lang="fi-FI" sz="2000" b="1" dirty="0"/>
              <a:t>, and PMOD</a:t>
            </a:r>
            <a:endParaRPr lang="fi-FI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600" dirty="0"/>
              <a:t>Sergey V. Nesterov, Roberto </a:t>
            </a:r>
            <a:r>
              <a:rPr lang="en-US" altLang="en-US" sz="1600" dirty="0" err="1"/>
              <a:t>Sciagrà</a:t>
            </a:r>
            <a:r>
              <a:rPr lang="en-US" altLang="en-US" sz="1600" dirty="0"/>
              <a:t>, Luis Eduardo Juarez Orozco, John O. Prior, Leonardo </a:t>
            </a:r>
            <a:r>
              <a:rPr lang="en-US" altLang="en-US" sz="1600" dirty="0" err="1"/>
              <a:t>Settimo</a:t>
            </a:r>
            <a:r>
              <a:rPr lang="en-US" altLang="en-US" sz="1600" dirty="0"/>
              <a:t>, </a:t>
            </a:r>
            <a:r>
              <a:rPr lang="en-US" altLang="en-US" sz="1600" dirty="0" err="1"/>
              <a:t>Chunlei</a:t>
            </a:r>
            <a:r>
              <a:rPr lang="en-US" altLang="en-US" sz="1600" dirty="0"/>
              <a:t> Han, Emmanuel </a:t>
            </a:r>
            <a:r>
              <a:rPr lang="en-US" altLang="en-US" sz="1600" dirty="0" err="1"/>
              <a:t>Deshayes</a:t>
            </a:r>
            <a:r>
              <a:rPr lang="en-US" altLang="en-US" sz="1600" dirty="0"/>
              <a:t>, Robert A. </a:t>
            </a:r>
            <a:r>
              <a:rPr lang="en-US" altLang="en-US" sz="1600" dirty="0" err="1"/>
              <a:t>deKemp</a:t>
            </a:r>
            <a:r>
              <a:rPr lang="en-US" altLang="en-US" sz="1600" dirty="0"/>
              <a:t>,, </a:t>
            </a:r>
            <a:r>
              <a:rPr lang="en-US" altLang="en-US" sz="1600" dirty="0" err="1"/>
              <a:t>Darja</a:t>
            </a:r>
            <a:r>
              <a:rPr lang="en-US" altLang="en-US" sz="1600" dirty="0"/>
              <a:t> V. </a:t>
            </a:r>
            <a:r>
              <a:rPr lang="en-US" altLang="en-US" sz="1600" dirty="0" err="1"/>
              <a:t>Ryzhkova</a:t>
            </a:r>
            <a:r>
              <a:rPr lang="en-US" altLang="en-US" sz="1600" dirty="0"/>
              <a:t>, </a:t>
            </a:r>
            <a:r>
              <a:rPr lang="en-US" altLang="en-US" sz="1600" dirty="0" err="1"/>
              <a:t>Kilem</a:t>
            </a:r>
            <a:r>
              <a:rPr lang="en-US" altLang="en-US" sz="1600" dirty="0"/>
              <a:t> L. </a:t>
            </a:r>
            <a:r>
              <a:rPr lang="en-US" altLang="en-US" sz="1600" dirty="0" err="1"/>
              <a:t>Gwet</a:t>
            </a:r>
            <a:r>
              <a:rPr lang="en-US" altLang="en-US" sz="1600" dirty="0"/>
              <a:t>, Juhani M. Knuuti</a:t>
            </a:r>
            <a:endParaRPr lang="en-US" altLang="en-US" sz="36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Kuva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3854579"/>
            <a:ext cx="2007059" cy="2007059"/>
          </a:xfrm>
          <a:prstGeom prst="rect">
            <a:avLst/>
          </a:prstGeom>
        </p:spPr>
      </p:pic>
      <p:pic>
        <p:nvPicPr>
          <p:cNvPr id="6" name="Kuva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86153" y="3854579"/>
            <a:ext cx="2819400" cy="231834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r>
              <a:rPr lang="en-US" altLang="en-US" sz="2400" dirty="0"/>
              <a:t>PET myocardial perfusion quantification (MPQ) can provide clinically important information.</a:t>
            </a:r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endParaRPr lang="en-US" altLang="en-US" sz="2400" dirty="0"/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r>
              <a:rPr lang="en-US" altLang="en-US" sz="2400" dirty="0"/>
              <a:t>Used software packages (SPs) can be a cause of PET MPQ results variability.</a:t>
            </a:r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endParaRPr lang="en-US" altLang="en-US" sz="2400" dirty="0"/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r>
              <a:rPr lang="en-US" altLang="en-US" sz="2400" dirty="0"/>
              <a:t>This study checked the agreement of N-13 ammonia PET MPQ of three SPs—</a:t>
            </a:r>
            <a:r>
              <a:rPr lang="en-US" altLang="en-US" sz="2400" dirty="0" err="1"/>
              <a:t>Carimas</a:t>
            </a:r>
            <a:r>
              <a:rPr lang="en-US" altLang="en-US" sz="2400" dirty="0"/>
              <a:t>, </a:t>
            </a:r>
            <a:r>
              <a:rPr lang="en-US" altLang="en-US" sz="2400" dirty="0" err="1"/>
              <a:t>FlowQuant</a:t>
            </a:r>
            <a:r>
              <a:rPr lang="en-US" altLang="en-US" sz="2400" dirty="0"/>
              <a:t>, and PMOD.</a:t>
            </a:r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endParaRPr lang="en-US" altLang="en-US" sz="2400" dirty="0"/>
          </a:p>
          <a:p>
            <a:pPr marL="457200" indent="-457200">
              <a:spcBef>
                <a:spcPts val="0"/>
              </a:spcBef>
              <a:buFont typeface="+mj-lt"/>
              <a:buAutoNum type="arabicPeriod"/>
            </a:pPr>
            <a:r>
              <a:rPr lang="en-US" altLang="en-US" sz="2400" dirty="0"/>
              <a:t>We performed MPQ agreement evaluation at three segmentation levels—global, regional, and segmental. </a:t>
            </a: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 </a:t>
            </a:r>
            <a:r>
              <a:rPr lang="fi-FI" sz="2800" b="1" dirty="0" err="1"/>
              <a:t>Retrospective</a:t>
            </a:r>
            <a:r>
              <a:rPr lang="fi-FI" sz="2800" b="1" dirty="0"/>
              <a:t> </a:t>
            </a:r>
            <a:r>
              <a:rPr lang="fi-FI" sz="2800" b="1" dirty="0" err="1"/>
              <a:t>study</a:t>
            </a:r>
            <a:r>
              <a:rPr lang="fi-FI" sz="2800" b="1" dirty="0"/>
              <a:t>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fi-FI" sz="2800" b="1" dirty="0"/>
              <a:t>48 </a:t>
            </a:r>
            <a:r>
              <a:rPr lang="fi-FI" sz="2800" b="1" dirty="0" err="1"/>
              <a:t>patients</a:t>
            </a:r>
            <a:r>
              <a:rPr lang="fi-FI" sz="2800" b="1" dirty="0"/>
              <a:t> </a:t>
            </a:r>
            <a:r>
              <a:rPr lang="fi-FI" sz="2800" b="1" dirty="0" err="1"/>
              <a:t>with</a:t>
            </a:r>
            <a:r>
              <a:rPr lang="fi-FI" sz="2800" b="1" dirty="0"/>
              <a:t> </a:t>
            </a:r>
            <a:r>
              <a:rPr lang="fi-FI" sz="2800" b="1" dirty="0" err="1"/>
              <a:t>known</a:t>
            </a:r>
            <a:r>
              <a:rPr lang="fi-FI" sz="2800" b="1" dirty="0"/>
              <a:t> HCM </a:t>
            </a:r>
            <a:r>
              <a:rPr lang="fi-FI" sz="2800" b="1" dirty="0" err="1"/>
              <a:t>who</a:t>
            </a:r>
            <a:r>
              <a:rPr lang="fi-FI" sz="2800" b="1" dirty="0"/>
              <a:t> </a:t>
            </a:r>
            <a:r>
              <a:rPr lang="fi-FI" sz="2800" b="1" dirty="0" err="1"/>
              <a:t>were</a:t>
            </a:r>
            <a:r>
              <a:rPr lang="fi-FI" sz="2800" b="1" dirty="0"/>
              <a:t> </a:t>
            </a:r>
            <a:r>
              <a:rPr lang="fi-FI" sz="2800" b="1" dirty="0" err="1"/>
              <a:t>referred</a:t>
            </a:r>
            <a:r>
              <a:rPr lang="fi-FI" sz="2800" b="1" dirty="0"/>
              <a:t> to PET MPQ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: </a:t>
            </a:r>
            <a:r>
              <a:rPr lang="en-US" altLang="en-US" sz="2400" b="1" dirty="0"/>
              <a:t>To establish the agreement of the three studied software packages on three levels of segmentation.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: </a:t>
            </a:r>
            <a:r>
              <a:rPr lang="en-US" altLang="en-US" sz="2400" b="1" dirty="0"/>
              <a:t>To establish the interchangeability of SP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altLang="en-US" sz="2800" b="1" dirty="0"/>
              <a:t>stress MBF, diff. between stress MBF values, ICC</a:t>
            </a:r>
            <a:r>
              <a:rPr lang="en-US" altLang="en-US" sz="2800" dirty="0"/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Chart 4">
            <a:extLst>
              <a:ext uri="{FF2B5EF4-FFF2-40B4-BE49-F238E27FC236}">
                <a16:creationId xmlns:a16="http://schemas.microsoft.com/office/drawing/2014/main" id="{51C3C34B-87D3-4849-8058-3492D91C802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33083604"/>
              </p:ext>
            </p:extLst>
          </p:nvPr>
        </p:nvGraphicFramePr>
        <p:xfrm>
          <a:off x="609600" y="1385541"/>
          <a:ext cx="7871460" cy="3741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Suorakulmio 5"/>
          <p:cNvSpPr/>
          <p:nvPr/>
        </p:nvSpPr>
        <p:spPr>
          <a:xfrm>
            <a:off x="609600" y="5141257"/>
            <a:ext cx="74179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b="1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.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es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BF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obal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ional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i-FI" dirty="0"/>
          </a:p>
        </p:txBody>
      </p:sp>
      <p:sp>
        <p:nvSpPr>
          <p:cNvPr id="14" name="Suorakulmio 13"/>
          <p:cNvSpPr/>
          <p:nvPr/>
        </p:nvSpPr>
        <p:spPr>
          <a:xfrm>
            <a:off x="609600" y="5445914"/>
            <a:ext cx="6934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X-axis is the difference in MBF values expressed in percent of corresponding medians; Y-axis is 1-ICC. </a:t>
            </a:r>
            <a:r>
              <a:rPr lang="en-US" sz="1200" dirty="0">
                <a:solidFill>
                  <a:srgbClr val="CC66FF"/>
                </a:solidFill>
              </a:rPr>
              <a:t>The shaded iris area</a:t>
            </a:r>
            <a:r>
              <a:rPr lang="en-US" sz="1200" dirty="0"/>
              <a:t> limits the acceptable agreement: ± 20% of the median value on the X-axis and ICCs over 0.75 on the Y-axis. The chart element corresponds to the comparison in the left ventricle area of the same name. C2 stands for </a:t>
            </a:r>
            <a:r>
              <a:rPr lang="en-US" sz="1200" dirty="0" err="1"/>
              <a:t>Carimas</a:t>
            </a:r>
            <a:r>
              <a:rPr lang="en-US" sz="1200" dirty="0"/>
              <a:t>, FQ for </a:t>
            </a:r>
            <a:r>
              <a:rPr lang="en-US" sz="1200" dirty="0" err="1"/>
              <a:t>FlowQuant</a:t>
            </a:r>
            <a:r>
              <a:rPr lang="en-US" sz="1200" dirty="0"/>
              <a:t>, PM for PMOD.</a:t>
            </a:r>
            <a:endParaRPr lang="fi-FI" sz="12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Suorakulmio 5"/>
          <p:cNvSpPr/>
          <p:nvPr/>
        </p:nvSpPr>
        <p:spPr>
          <a:xfrm>
            <a:off x="609600" y="5141257"/>
            <a:ext cx="74179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b="1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.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es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BF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gmental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i-FI" dirty="0" err="1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vels</a:t>
            </a:r>
            <a:r>
              <a:rPr lang="fi-FI" dirty="0">
                <a:solidFill>
                  <a:srgbClr val="403838"/>
                </a:solidFill>
                <a:latin typeface="Garamond" panose="02020404030301010803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i-FI" dirty="0"/>
          </a:p>
        </p:txBody>
      </p:sp>
      <p:sp>
        <p:nvSpPr>
          <p:cNvPr id="14" name="Suorakulmio 13"/>
          <p:cNvSpPr/>
          <p:nvPr/>
        </p:nvSpPr>
        <p:spPr>
          <a:xfrm>
            <a:off x="609600" y="5445914"/>
            <a:ext cx="6934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X-axis is the difference in MBF values expressed in percent of corresponding medians; Y-axis is 1-ICC. </a:t>
            </a:r>
            <a:r>
              <a:rPr lang="en-US" sz="1200" dirty="0">
                <a:solidFill>
                  <a:srgbClr val="CC66FF"/>
                </a:solidFill>
              </a:rPr>
              <a:t>The shaded iris area </a:t>
            </a:r>
            <a:r>
              <a:rPr lang="en-US" sz="1200" dirty="0"/>
              <a:t>limits the acceptable agreement: ± 20% of the median value on the X-axis and ICCs over 0.75 on the Y-axis. The chart element corresponds to the comparison in the left ventricle area of the same name. C2 stands for </a:t>
            </a:r>
            <a:r>
              <a:rPr lang="en-US" sz="1200" dirty="0" err="1"/>
              <a:t>Carimas</a:t>
            </a:r>
            <a:r>
              <a:rPr lang="en-US" sz="1200" dirty="0"/>
              <a:t>, FQ for </a:t>
            </a:r>
            <a:r>
              <a:rPr lang="en-US" sz="1200" dirty="0" err="1"/>
              <a:t>FlowQuant</a:t>
            </a:r>
            <a:r>
              <a:rPr lang="en-US" sz="1200" dirty="0"/>
              <a:t>, PM for PMOD.</a:t>
            </a:r>
            <a:endParaRPr lang="fi-FI" sz="1200" dirty="0"/>
          </a:p>
        </p:txBody>
      </p:sp>
      <p:graphicFrame>
        <p:nvGraphicFramePr>
          <p:cNvPr id="12" name="Chart 7">
            <a:extLst>
              <a:ext uri="{FF2B5EF4-FFF2-40B4-BE49-F238E27FC236}">
                <a16:creationId xmlns:a16="http://schemas.microsoft.com/office/drawing/2014/main" id="{F0E31EAE-7D41-4FF9-A1A9-EE5A377630D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08568438"/>
              </p:ext>
            </p:extLst>
          </p:nvPr>
        </p:nvGraphicFramePr>
        <p:xfrm>
          <a:off x="381000" y="1404937"/>
          <a:ext cx="8257540" cy="3823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5009091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.	</a:t>
            </a:r>
            <a:r>
              <a:rPr lang="en-US" altLang="en-US" sz="2400" dirty="0"/>
              <a:t>The global and regional MBF values (with one exception) agree well between the different software packages,</a:t>
            </a:r>
          </a:p>
          <a:p>
            <a:pPr marL="0" indent="0">
              <a:buNone/>
            </a:pPr>
            <a:r>
              <a:rPr lang="en-US" altLang="en-US" sz="2400" dirty="0"/>
              <a:t>2.	However, there is significant variability in segmental values, mainly located in the </a:t>
            </a:r>
            <a:r>
              <a:rPr lang="en-US" altLang="en-US" sz="2400" dirty="0" err="1"/>
              <a:t>LCx</a:t>
            </a:r>
            <a:r>
              <a:rPr lang="en-US" altLang="en-US" sz="2400" dirty="0"/>
              <a:t> region and segments.</a:t>
            </a:r>
          </a:p>
          <a:p>
            <a:pPr marL="0" indent="0">
              <a:buNone/>
            </a:pPr>
            <a:r>
              <a:rPr lang="en-US" altLang="en-US" sz="2400" dirty="0"/>
              <a:t>3.	Out of the studied tools, </a:t>
            </a:r>
            <a:r>
              <a:rPr lang="en-US" altLang="en-US" sz="2400" dirty="0" err="1"/>
              <a:t>Carimas</a:t>
            </a:r>
            <a:r>
              <a:rPr lang="en-US" altLang="en-US" sz="2400" dirty="0"/>
              <a:t> can be used interchangeably with both PMOD and </a:t>
            </a:r>
            <a:r>
              <a:rPr lang="en-US" altLang="en-US" sz="2400" dirty="0" err="1"/>
              <a:t>FlowQuant</a:t>
            </a:r>
            <a:r>
              <a:rPr lang="en-US" altLang="en-US" sz="2400" dirty="0"/>
              <a:t> for 1TCM implementation on all levels—global, regional, and segmental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00</TotalTime>
  <Words>602</Words>
  <Application>Microsoft Office PowerPoint</Application>
  <PresentationFormat>On-screen Show (4:3)</PresentationFormat>
  <Paragraphs>5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Garamond</vt:lpstr>
      <vt:lpstr>SsykbnAdvPTimes</vt:lpstr>
      <vt:lpstr>Times New Roman</vt:lpstr>
      <vt:lpstr>2_Office Theme</vt:lpstr>
      <vt:lpstr>Custom Design</vt:lpstr>
      <vt:lpstr>1_Custom Design</vt:lpstr>
      <vt:lpstr>One-tissue compartment model for myocardial perfusion quantification with N-13 ammonia PET provides matching results—a  cross-comparison between Carimas, FlowQuant, and PMOD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epta</cp:lastModifiedBy>
  <cp:revision>113</cp:revision>
  <cp:lastPrinted>2021-04-12T11:53:01Z</cp:lastPrinted>
  <dcterms:created xsi:type="dcterms:W3CDTF">2011-04-18T21:44:13Z</dcterms:created>
  <dcterms:modified xsi:type="dcterms:W3CDTF">2021-06-07T12:49:16Z</dcterms:modified>
</cp:coreProperties>
</file>